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27D044-5C55-47EE-BC93-DA0A317E34C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9B7583-8B19-4F42-9F44-61E041E664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5EDB76-F357-4906-B50B-AF7651D5555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9E5777-E13C-48F0-AAC6-B9A175E4189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151AC5-4AC0-46E3-B5E3-9FAF86F0974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48484B-E917-435D-AB96-78BA57CF9E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9A1D4D-9EA8-47A8-86D4-44FA33C5838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7E23EC-4B6E-4EF3-B8DA-5E540F1BFE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31C5EB-0A5F-4ED0-9E97-3D1D3723E98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2D2067-181D-4CF3-B8EF-70ED9AFFAD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677BC4-AFB7-4BF6-BAE8-296C55AB29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13C1BD-0BC7-4818-BAF0-7A159DAFD6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FFDA04F-0A60-4947-AA07-B56AE4EC131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571464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2: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QC of samples by standard deviation of Log R Ratio (LRR) and by SNP call rate  of the array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1828800" y="152280"/>
            <a:ext cx="5257800" cy="524196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7000920" y="57240"/>
            <a:ext cx="152280" cy="53337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1-23T22:36:52Z</dcterms:created>
  <dc:creator>mkibriya</dc:creator>
  <dc:description/>
  <dc:language>en-US</dc:language>
  <cp:lastModifiedBy>mkibriya</cp:lastModifiedBy>
  <dcterms:modified xsi:type="dcterms:W3CDTF">2017-03-29T18:44:15Z</dcterms:modified>
  <cp:revision>33</cp:revision>
  <dc:subject/>
  <dc:title>Slide 1</dc:title>
</cp:coreProperties>
</file>